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thumbnail" Target="docProps/thumbnail.jpeg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6" Type="http://schemas.openxmlformats.org/officeDocument/2006/relationships/custom-properties" Target="docProps/custom.xml"/><Relationship Id="rId5" Type="http://schemas.openxmlformats.org/officeDocument/2006/relationships/extended-properties" Target="docProps/app.xml"/><Relationship Id="rId4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9B882"/>
    <a:srgbClr val="354F5F"/>
    <a:srgbClr val="485063"/>
    <a:srgbClr val="343D52"/>
    <a:srgbClr val="152538"/>
    <a:srgbClr val="0C2D4C"/>
    <a:srgbClr val="2D3E55"/>
    <a:srgbClr val="011893"/>
    <a:srgbClr val="005493"/>
    <a:srgbClr val="0048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F81EE12-521D-4173-BB53-2275293E429C}" v="6" dt="2025-03-07T03:55:06.269"/>
    <p1510:client id="{7381B2A2-7A19-3C46-A8BC-1A28ACF42C30}" v="134" dt="2025-03-06T12:51:17.50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858"/>
    <p:restoredTop sz="94610"/>
  </p:normalViewPr>
  <p:slideViewPr>
    <p:cSldViewPr snapToGrid="0" snapToObjects="1">
      <p:cViewPr varScale="1">
        <p:scale>
          <a:sx n="122" d="100"/>
          <a:sy n="122" d="100"/>
        </p:scale>
        <p:origin x="108" y="6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livia Smibert" userId="3a5a476f-fd04-4679-896e-8d98dbcf1ee7" providerId="ADAL" clId="{6F81EE12-521D-4173-BB53-2275293E429C}"/>
    <pc:docChg chg="custSel modSld">
      <pc:chgData name="Olivia Smibert" userId="3a5a476f-fd04-4679-896e-8d98dbcf1ee7" providerId="ADAL" clId="{6F81EE12-521D-4173-BB53-2275293E429C}" dt="2025-03-07T03:56:26.514" v="45" actId="1076"/>
      <pc:docMkLst>
        <pc:docMk/>
      </pc:docMkLst>
      <pc:sldChg chg="modSp mod">
        <pc:chgData name="Olivia Smibert" userId="3a5a476f-fd04-4679-896e-8d98dbcf1ee7" providerId="ADAL" clId="{6F81EE12-521D-4173-BB53-2275293E429C}" dt="2025-03-07T03:56:26.514" v="45" actId="1076"/>
        <pc:sldMkLst>
          <pc:docMk/>
          <pc:sldMk cId="98051232" sldId="256"/>
        </pc:sldMkLst>
        <pc:spChg chg="mod">
          <ac:chgData name="Olivia Smibert" userId="3a5a476f-fd04-4679-896e-8d98dbcf1ee7" providerId="ADAL" clId="{6F81EE12-521D-4173-BB53-2275293E429C}" dt="2025-03-07T03:50:51.181" v="1" actId="20577"/>
          <ac:spMkLst>
            <pc:docMk/>
            <pc:sldMk cId="98051232" sldId="256"/>
            <ac:spMk id="3" creationId="{97FD39CF-48BE-F043-9CA6-1EA6F45D25E8}"/>
          </ac:spMkLst>
        </pc:spChg>
        <pc:spChg chg="mod">
          <ac:chgData name="Olivia Smibert" userId="3a5a476f-fd04-4679-896e-8d98dbcf1ee7" providerId="ADAL" clId="{6F81EE12-521D-4173-BB53-2275293E429C}" dt="2025-03-07T03:50:49.769" v="0" actId="20577"/>
          <ac:spMkLst>
            <pc:docMk/>
            <pc:sldMk cId="98051232" sldId="256"/>
            <ac:spMk id="27" creationId="{61DAB825-7476-4D47-7934-E4B49FB16C96}"/>
          </ac:spMkLst>
        </pc:spChg>
        <pc:spChg chg="mod">
          <ac:chgData name="Olivia Smibert" userId="3a5a476f-fd04-4679-896e-8d98dbcf1ee7" providerId="ADAL" clId="{6F81EE12-521D-4173-BB53-2275293E429C}" dt="2025-03-07T03:50:54.450" v="2" actId="20577"/>
          <ac:spMkLst>
            <pc:docMk/>
            <pc:sldMk cId="98051232" sldId="256"/>
            <ac:spMk id="29" creationId="{10F4F2D7-E84F-AD67-57B9-20AAE1242EBB}"/>
          </ac:spMkLst>
        </pc:spChg>
        <pc:spChg chg="mod">
          <ac:chgData name="Olivia Smibert" userId="3a5a476f-fd04-4679-896e-8d98dbcf1ee7" providerId="ADAL" clId="{6F81EE12-521D-4173-BB53-2275293E429C}" dt="2025-03-07T03:50:59.421" v="3" actId="20577"/>
          <ac:spMkLst>
            <pc:docMk/>
            <pc:sldMk cId="98051232" sldId="256"/>
            <ac:spMk id="36" creationId="{C77ACCA1-0D18-F86B-A4F8-C15885BCF921}"/>
          </ac:spMkLst>
        </pc:spChg>
        <pc:spChg chg="mod">
          <ac:chgData name="Olivia Smibert" userId="3a5a476f-fd04-4679-896e-8d98dbcf1ee7" providerId="ADAL" clId="{6F81EE12-521D-4173-BB53-2275293E429C}" dt="2025-03-07T03:55:01.541" v="34" actId="14100"/>
          <ac:spMkLst>
            <pc:docMk/>
            <pc:sldMk cId="98051232" sldId="256"/>
            <ac:spMk id="37" creationId="{E687DFCA-74D2-A527-D73B-1A375D6FD194}"/>
          </ac:spMkLst>
        </pc:spChg>
        <pc:spChg chg="mod">
          <ac:chgData name="Olivia Smibert" userId="3a5a476f-fd04-4679-896e-8d98dbcf1ee7" providerId="ADAL" clId="{6F81EE12-521D-4173-BB53-2275293E429C}" dt="2025-03-07T03:51:08.687" v="4" actId="20577"/>
          <ac:spMkLst>
            <pc:docMk/>
            <pc:sldMk cId="98051232" sldId="256"/>
            <ac:spMk id="49" creationId="{F751F9A9-B0DA-9C3C-7F7F-D139814E243B}"/>
          </ac:spMkLst>
        </pc:spChg>
        <pc:spChg chg="mod">
          <ac:chgData name="Olivia Smibert" userId="3a5a476f-fd04-4679-896e-8d98dbcf1ee7" providerId="ADAL" clId="{6F81EE12-521D-4173-BB53-2275293E429C}" dt="2025-03-07T03:56:26.514" v="45" actId="1076"/>
          <ac:spMkLst>
            <pc:docMk/>
            <pc:sldMk cId="98051232" sldId="256"/>
            <ac:spMk id="53" creationId="{2A73F70A-6964-76BD-5173-B82827E85316}"/>
          </ac:spMkLst>
        </pc:spChg>
        <pc:picChg chg="mod">
          <ac:chgData name="Olivia Smibert" userId="3a5a476f-fd04-4679-896e-8d98dbcf1ee7" providerId="ADAL" clId="{6F81EE12-521D-4173-BB53-2275293E429C}" dt="2025-03-07T03:55:06.269" v="35" actId="1076"/>
          <ac:picMkLst>
            <pc:docMk/>
            <pc:sldMk cId="98051232" sldId="256"/>
            <ac:picMk id="40" creationId="{9165E86F-788B-4CFC-CACE-554669A539D1}"/>
          </ac:picMkLst>
        </pc:picChg>
        <pc:picChg chg="mod">
          <ac:chgData name="Olivia Smibert" userId="3a5a476f-fd04-4679-896e-8d98dbcf1ee7" providerId="ADAL" clId="{6F81EE12-521D-4173-BB53-2275293E429C}" dt="2025-03-07T03:52:14.583" v="28" actId="1076"/>
          <ac:picMkLst>
            <pc:docMk/>
            <pc:sldMk cId="98051232" sldId="256"/>
            <ac:picMk id="47" creationId="{06A7FB43-8CD0-E4A8-9F3D-7265A8154B2C}"/>
          </ac:picMkLst>
        </pc:picChg>
      </pc:sldChg>
    </pc:docChg>
  </pc:docChgLst>
  <pc:docChgLst>
    <pc:chgData name="Olivia Smibert" userId="3a5a476f-fd04-4679-896e-8d98dbcf1ee7" providerId="ADAL" clId="{7381B2A2-7A19-3C46-A8BC-1A28ACF42C30}"/>
    <pc:docChg chg="undo custSel modSld">
      <pc:chgData name="Olivia Smibert" userId="3a5a476f-fd04-4679-896e-8d98dbcf1ee7" providerId="ADAL" clId="{7381B2A2-7A19-3C46-A8BC-1A28ACF42C30}" dt="2025-03-06T12:55:02.242" v="1551" actId="1076"/>
      <pc:docMkLst>
        <pc:docMk/>
      </pc:docMkLst>
      <pc:sldChg chg="addSp delSp modSp mod">
        <pc:chgData name="Olivia Smibert" userId="3a5a476f-fd04-4679-896e-8d98dbcf1ee7" providerId="ADAL" clId="{7381B2A2-7A19-3C46-A8BC-1A28ACF42C30}" dt="2025-03-06T12:55:02.242" v="1551" actId="1076"/>
        <pc:sldMkLst>
          <pc:docMk/>
          <pc:sldMk cId="98051232" sldId="256"/>
        </pc:sldMkLst>
        <pc:spChg chg="mod">
          <ac:chgData name="Olivia Smibert" userId="3a5a476f-fd04-4679-896e-8d98dbcf1ee7" providerId="ADAL" clId="{7381B2A2-7A19-3C46-A8BC-1A28ACF42C30}" dt="2025-03-06T12:55:02.242" v="1551" actId="1076"/>
          <ac:spMkLst>
            <pc:docMk/>
            <pc:sldMk cId="98051232" sldId="256"/>
            <ac:spMk id="3" creationId="{97FD39CF-48BE-F043-9CA6-1EA6F45D25E8}"/>
          </ac:spMkLst>
        </pc:spChg>
        <pc:spChg chg="del mod">
          <ac:chgData name="Olivia Smibert" userId="3a5a476f-fd04-4679-896e-8d98dbcf1ee7" providerId="ADAL" clId="{7381B2A2-7A19-3C46-A8BC-1A28ACF42C30}" dt="2025-03-06T12:19:31.874" v="486" actId="478"/>
          <ac:spMkLst>
            <pc:docMk/>
            <pc:sldMk cId="98051232" sldId="256"/>
            <ac:spMk id="4" creationId="{84D2DC7B-8F20-DB06-FA39-A375E064393A}"/>
          </ac:spMkLst>
        </pc:spChg>
        <pc:spChg chg="del mod">
          <ac:chgData name="Olivia Smibert" userId="3a5a476f-fd04-4679-896e-8d98dbcf1ee7" providerId="ADAL" clId="{7381B2A2-7A19-3C46-A8BC-1A28ACF42C30}" dt="2025-03-06T11:52:05.905" v="37" actId="478"/>
          <ac:spMkLst>
            <pc:docMk/>
            <pc:sldMk cId="98051232" sldId="256"/>
            <ac:spMk id="6" creationId="{B4C266D5-3474-D76F-6646-EB5585B0764F}"/>
          </ac:spMkLst>
        </pc:spChg>
        <pc:spChg chg="del mod">
          <ac:chgData name="Olivia Smibert" userId="3a5a476f-fd04-4679-896e-8d98dbcf1ee7" providerId="ADAL" clId="{7381B2A2-7A19-3C46-A8BC-1A28ACF42C30}" dt="2025-03-06T12:19:33.614" v="487" actId="478"/>
          <ac:spMkLst>
            <pc:docMk/>
            <pc:sldMk cId="98051232" sldId="256"/>
            <ac:spMk id="7" creationId="{1D3F98DC-ACB6-4B13-63C2-5D6688813324}"/>
          </ac:spMkLst>
        </pc:spChg>
        <pc:spChg chg="del">
          <ac:chgData name="Olivia Smibert" userId="3a5a476f-fd04-4679-896e-8d98dbcf1ee7" providerId="ADAL" clId="{7381B2A2-7A19-3C46-A8BC-1A28ACF42C30}" dt="2025-03-06T11:52:03.133" v="35" actId="478"/>
          <ac:spMkLst>
            <pc:docMk/>
            <pc:sldMk cId="98051232" sldId="256"/>
            <ac:spMk id="8" creationId="{BB2FD0D9-C076-9496-42BA-9B503D218313}"/>
          </ac:spMkLst>
        </pc:spChg>
        <pc:spChg chg="del">
          <ac:chgData name="Olivia Smibert" userId="3a5a476f-fd04-4679-896e-8d98dbcf1ee7" providerId="ADAL" clId="{7381B2A2-7A19-3C46-A8BC-1A28ACF42C30}" dt="2025-03-06T11:50:31.279" v="10" actId="478"/>
          <ac:spMkLst>
            <pc:docMk/>
            <pc:sldMk cId="98051232" sldId="256"/>
            <ac:spMk id="10" creationId="{CEF8CB05-D943-B18F-33EA-FF4A5D229585}"/>
          </ac:spMkLst>
        </pc:spChg>
        <pc:spChg chg="del">
          <ac:chgData name="Olivia Smibert" userId="3a5a476f-fd04-4679-896e-8d98dbcf1ee7" providerId="ADAL" clId="{7381B2A2-7A19-3C46-A8BC-1A28ACF42C30}" dt="2025-03-06T11:50:28.681" v="9" actId="478"/>
          <ac:spMkLst>
            <pc:docMk/>
            <pc:sldMk cId="98051232" sldId="256"/>
            <ac:spMk id="11" creationId="{7EADBEFF-514C-747F-DA98-AFF7129528E1}"/>
          </ac:spMkLst>
        </pc:spChg>
        <pc:spChg chg="del">
          <ac:chgData name="Olivia Smibert" userId="3a5a476f-fd04-4679-896e-8d98dbcf1ee7" providerId="ADAL" clId="{7381B2A2-7A19-3C46-A8BC-1A28ACF42C30}" dt="2025-03-06T11:50:33.419" v="11" actId="478"/>
          <ac:spMkLst>
            <pc:docMk/>
            <pc:sldMk cId="98051232" sldId="256"/>
            <ac:spMk id="12" creationId="{1692B36D-6628-3CDA-D26A-262E6F7CAA23}"/>
          </ac:spMkLst>
        </pc:spChg>
        <pc:spChg chg="del">
          <ac:chgData name="Olivia Smibert" userId="3a5a476f-fd04-4679-896e-8d98dbcf1ee7" providerId="ADAL" clId="{7381B2A2-7A19-3C46-A8BC-1A28ACF42C30}" dt="2025-03-06T11:52:02.012" v="34" actId="478"/>
          <ac:spMkLst>
            <pc:docMk/>
            <pc:sldMk cId="98051232" sldId="256"/>
            <ac:spMk id="15" creationId="{1154436D-B543-8FAF-F7DB-A5BE871A0632}"/>
          </ac:spMkLst>
        </pc:spChg>
        <pc:spChg chg="add mod">
          <ac:chgData name="Olivia Smibert" userId="3a5a476f-fd04-4679-896e-8d98dbcf1ee7" providerId="ADAL" clId="{7381B2A2-7A19-3C46-A8BC-1A28ACF42C30}" dt="2025-03-06T12:11:29.124" v="421" actId="1076"/>
          <ac:spMkLst>
            <pc:docMk/>
            <pc:sldMk cId="98051232" sldId="256"/>
            <ac:spMk id="17" creationId="{D9141940-3562-BD18-FFC6-F74D7BD9D4E3}"/>
          </ac:spMkLst>
        </pc:spChg>
        <pc:spChg chg="add del mod">
          <ac:chgData name="Olivia Smibert" userId="3a5a476f-fd04-4679-896e-8d98dbcf1ee7" providerId="ADAL" clId="{7381B2A2-7A19-3C46-A8BC-1A28ACF42C30}" dt="2025-03-06T11:50:48.005" v="16" actId="478"/>
          <ac:spMkLst>
            <pc:docMk/>
            <pc:sldMk cId="98051232" sldId="256"/>
            <ac:spMk id="18" creationId="{523695F4-E221-2BEC-CDB9-74A70AE3810C}"/>
          </ac:spMkLst>
        </pc:spChg>
        <pc:spChg chg="add del mod">
          <ac:chgData name="Olivia Smibert" userId="3a5a476f-fd04-4679-896e-8d98dbcf1ee7" providerId="ADAL" clId="{7381B2A2-7A19-3C46-A8BC-1A28ACF42C30}" dt="2025-03-06T11:51:32.921" v="26" actId="478"/>
          <ac:spMkLst>
            <pc:docMk/>
            <pc:sldMk cId="98051232" sldId="256"/>
            <ac:spMk id="19" creationId="{E4B37B6B-2DA8-CD7F-6111-12B179901308}"/>
          </ac:spMkLst>
        </pc:spChg>
        <pc:spChg chg="add del mod">
          <ac:chgData name="Olivia Smibert" userId="3a5a476f-fd04-4679-896e-8d98dbcf1ee7" providerId="ADAL" clId="{7381B2A2-7A19-3C46-A8BC-1A28ACF42C30}" dt="2025-03-06T11:51:33.532" v="27" actId="478"/>
          <ac:spMkLst>
            <pc:docMk/>
            <pc:sldMk cId="98051232" sldId="256"/>
            <ac:spMk id="20" creationId="{E3BD4837-3E40-B25E-B9DF-613C8B7346A9}"/>
          </ac:spMkLst>
        </pc:spChg>
        <pc:spChg chg="add mod">
          <ac:chgData name="Olivia Smibert" userId="3a5a476f-fd04-4679-896e-8d98dbcf1ee7" providerId="ADAL" clId="{7381B2A2-7A19-3C46-A8BC-1A28ACF42C30}" dt="2025-03-06T11:52:39.608" v="91" actId="255"/>
          <ac:spMkLst>
            <pc:docMk/>
            <pc:sldMk cId="98051232" sldId="256"/>
            <ac:spMk id="21" creationId="{AEB703E2-2E56-5A2E-9895-9E006E9262FD}"/>
          </ac:spMkLst>
        </pc:spChg>
        <pc:spChg chg="add mod">
          <ac:chgData name="Olivia Smibert" userId="3a5a476f-fd04-4679-896e-8d98dbcf1ee7" providerId="ADAL" clId="{7381B2A2-7A19-3C46-A8BC-1A28ACF42C30}" dt="2025-03-06T11:52:47.586" v="104" actId="20577"/>
          <ac:spMkLst>
            <pc:docMk/>
            <pc:sldMk cId="98051232" sldId="256"/>
            <ac:spMk id="22" creationId="{78F022BA-B0D8-2485-C948-289D98B3E501}"/>
          </ac:spMkLst>
        </pc:spChg>
        <pc:spChg chg="add mod">
          <ac:chgData name="Olivia Smibert" userId="3a5a476f-fd04-4679-896e-8d98dbcf1ee7" providerId="ADAL" clId="{7381B2A2-7A19-3C46-A8BC-1A28ACF42C30}" dt="2025-03-06T12:21:21.345" v="540" actId="1076"/>
          <ac:spMkLst>
            <pc:docMk/>
            <pc:sldMk cId="98051232" sldId="256"/>
            <ac:spMk id="23" creationId="{5FD14A22-A1D7-4FAB-5CA2-C6D764E4A793}"/>
          </ac:spMkLst>
        </pc:spChg>
        <pc:spChg chg="add mod">
          <ac:chgData name="Olivia Smibert" userId="3a5a476f-fd04-4679-896e-8d98dbcf1ee7" providerId="ADAL" clId="{7381B2A2-7A19-3C46-A8BC-1A28ACF42C30}" dt="2025-03-06T12:21:15.158" v="539" actId="14100"/>
          <ac:spMkLst>
            <pc:docMk/>
            <pc:sldMk cId="98051232" sldId="256"/>
            <ac:spMk id="24" creationId="{B4F1A0A9-1E57-415D-D4EB-3B73172FFA4E}"/>
          </ac:spMkLst>
        </pc:spChg>
        <pc:spChg chg="add mod">
          <ac:chgData name="Olivia Smibert" userId="3a5a476f-fd04-4679-896e-8d98dbcf1ee7" providerId="ADAL" clId="{7381B2A2-7A19-3C46-A8BC-1A28ACF42C30}" dt="2025-03-06T12:21:32.618" v="544" actId="1076"/>
          <ac:spMkLst>
            <pc:docMk/>
            <pc:sldMk cId="98051232" sldId="256"/>
            <ac:spMk id="25" creationId="{06D28810-CF13-8315-51F1-7C5C7971EAC7}"/>
          </ac:spMkLst>
        </pc:spChg>
        <pc:spChg chg="add del mod">
          <ac:chgData name="Olivia Smibert" userId="3a5a476f-fd04-4679-896e-8d98dbcf1ee7" providerId="ADAL" clId="{7381B2A2-7A19-3C46-A8BC-1A28ACF42C30}" dt="2025-03-06T12:03:19.674" v="386" actId="478"/>
          <ac:spMkLst>
            <pc:docMk/>
            <pc:sldMk cId="98051232" sldId="256"/>
            <ac:spMk id="26" creationId="{78F2A225-FFF4-7F9A-A0D1-6939DE354EA3}"/>
          </ac:spMkLst>
        </pc:spChg>
        <pc:spChg chg="add mod">
          <ac:chgData name="Olivia Smibert" userId="3a5a476f-fd04-4679-896e-8d98dbcf1ee7" providerId="ADAL" clId="{7381B2A2-7A19-3C46-A8BC-1A28ACF42C30}" dt="2025-03-06T12:49:02.671" v="1021" actId="20577"/>
          <ac:spMkLst>
            <pc:docMk/>
            <pc:sldMk cId="98051232" sldId="256"/>
            <ac:spMk id="27" creationId="{61DAB825-7476-4D47-7934-E4B49FB16C96}"/>
          </ac:spMkLst>
        </pc:spChg>
        <pc:spChg chg="add mod">
          <ac:chgData name="Olivia Smibert" userId="3a5a476f-fd04-4679-896e-8d98dbcf1ee7" providerId="ADAL" clId="{7381B2A2-7A19-3C46-A8BC-1A28ACF42C30}" dt="2025-03-06T12:21:34.972" v="545" actId="1076"/>
          <ac:spMkLst>
            <pc:docMk/>
            <pc:sldMk cId="98051232" sldId="256"/>
            <ac:spMk id="28" creationId="{60B4E0FD-4159-7794-0E7E-A16AA7FA4E42}"/>
          </ac:spMkLst>
        </pc:spChg>
        <pc:spChg chg="add mod">
          <ac:chgData name="Olivia Smibert" userId="3a5a476f-fd04-4679-896e-8d98dbcf1ee7" providerId="ADAL" clId="{7381B2A2-7A19-3C46-A8BC-1A28ACF42C30}" dt="2025-03-06T12:20:05.612" v="495" actId="1076"/>
          <ac:spMkLst>
            <pc:docMk/>
            <pc:sldMk cId="98051232" sldId="256"/>
            <ac:spMk id="29" creationId="{10F4F2D7-E84F-AD67-57B9-20AAE1242EBB}"/>
          </ac:spMkLst>
        </pc:spChg>
        <pc:spChg chg="add mod">
          <ac:chgData name="Olivia Smibert" userId="3a5a476f-fd04-4679-896e-8d98dbcf1ee7" providerId="ADAL" clId="{7381B2A2-7A19-3C46-A8BC-1A28ACF42C30}" dt="2025-03-06T12:21:27.565" v="542" actId="1076"/>
          <ac:spMkLst>
            <pc:docMk/>
            <pc:sldMk cId="98051232" sldId="256"/>
            <ac:spMk id="30" creationId="{573B431C-4AE0-895A-0B52-02E6B7E1AE6F}"/>
          </ac:spMkLst>
        </pc:spChg>
        <pc:spChg chg="add mod">
          <ac:chgData name="Olivia Smibert" userId="3a5a476f-fd04-4679-896e-8d98dbcf1ee7" providerId="ADAL" clId="{7381B2A2-7A19-3C46-A8BC-1A28ACF42C30}" dt="2025-03-06T12:21:30.167" v="543" actId="1076"/>
          <ac:spMkLst>
            <pc:docMk/>
            <pc:sldMk cId="98051232" sldId="256"/>
            <ac:spMk id="31" creationId="{D703F090-72E4-76A8-067D-05D1A4C73A78}"/>
          </ac:spMkLst>
        </pc:spChg>
        <pc:spChg chg="add mod">
          <ac:chgData name="Olivia Smibert" userId="3a5a476f-fd04-4679-896e-8d98dbcf1ee7" providerId="ADAL" clId="{7381B2A2-7A19-3C46-A8BC-1A28ACF42C30}" dt="2025-03-06T12:23:20.558" v="558" actId="1076"/>
          <ac:spMkLst>
            <pc:docMk/>
            <pc:sldMk cId="98051232" sldId="256"/>
            <ac:spMk id="33" creationId="{DDF84AE8-A076-1940-998C-6485E8E29A08}"/>
          </ac:spMkLst>
        </pc:spChg>
        <pc:spChg chg="add del mod">
          <ac:chgData name="Olivia Smibert" userId="3a5a476f-fd04-4679-896e-8d98dbcf1ee7" providerId="ADAL" clId="{7381B2A2-7A19-3C46-A8BC-1A28ACF42C30}" dt="2025-03-06T12:43:06.969" v="834" actId="478"/>
          <ac:spMkLst>
            <pc:docMk/>
            <pc:sldMk cId="98051232" sldId="256"/>
            <ac:spMk id="34" creationId="{C3789B62-6949-E4B0-6399-E0DDF1724293}"/>
          </ac:spMkLst>
        </pc:spChg>
        <pc:spChg chg="add mod">
          <ac:chgData name="Olivia Smibert" userId="3a5a476f-fd04-4679-896e-8d98dbcf1ee7" providerId="ADAL" clId="{7381B2A2-7A19-3C46-A8BC-1A28ACF42C30}" dt="2025-03-06T12:45:08.809" v="963" actId="14100"/>
          <ac:spMkLst>
            <pc:docMk/>
            <pc:sldMk cId="98051232" sldId="256"/>
            <ac:spMk id="35" creationId="{711A303D-F64B-608B-785C-4943300DC2AC}"/>
          </ac:spMkLst>
        </pc:spChg>
        <pc:spChg chg="add mod">
          <ac:chgData name="Olivia Smibert" userId="3a5a476f-fd04-4679-896e-8d98dbcf1ee7" providerId="ADAL" clId="{7381B2A2-7A19-3C46-A8BC-1A28ACF42C30}" dt="2025-03-06T12:45:35.089" v="967" actId="1076"/>
          <ac:spMkLst>
            <pc:docMk/>
            <pc:sldMk cId="98051232" sldId="256"/>
            <ac:spMk id="36" creationId="{C77ACCA1-0D18-F86B-A4F8-C15885BCF921}"/>
          </ac:spMkLst>
        </pc:spChg>
        <pc:spChg chg="add mod">
          <ac:chgData name="Olivia Smibert" userId="3a5a476f-fd04-4679-896e-8d98dbcf1ee7" providerId="ADAL" clId="{7381B2A2-7A19-3C46-A8BC-1A28ACF42C30}" dt="2025-03-06T12:50:10.798" v="1093" actId="20577"/>
          <ac:spMkLst>
            <pc:docMk/>
            <pc:sldMk cId="98051232" sldId="256"/>
            <ac:spMk id="37" creationId="{E687DFCA-74D2-A527-D73B-1A375D6FD194}"/>
          </ac:spMkLst>
        </pc:spChg>
        <pc:spChg chg="add del mod">
          <ac:chgData name="Olivia Smibert" userId="3a5a476f-fd04-4679-896e-8d98dbcf1ee7" providerId="ADAL" clId="{7381B2A2-7A19-3C46-A8BC-1A28ACF42C30}" dt="2025-03-06T12:43:06.126" v="833" actId="478"/>
          <ac:spMkLst>
            <pc:docMk/>
            <pc:sldMk cId="98051232" sldId="256"/>
            <ac:spMk id="39" creationId="{49BBE83A-F9CF-8928-D516-B8065510CD56}"/>
          </ac:spMkLst>
        </pc:spChg>
        <pc:spChg chg="add del mod">
          <ac:chgData name="Olivia Smibert" userId="3a5a476f-fd04-4679-896e-8d98dbcf1ee7" providerId="ADAL" clId="{7381B2A2-7A19-3C46-A8BC-1A28ACF42C30}" dt="2025-03-06T12:41:53.027" v="693" actId="478"/>
          <ac:spMkLst>
            <pc:docMk/>
            <pc:sldMk cId="98051232" sldId="256"/>
            <ac:spMk id="42" creationId="{C3CFB899-6A43-4A49-FCA0-C84968381A7C}"/>
          </ac:spMkLst>
        </pc:spChg>
        <pc:spChg chg="add del mod">
          <ac:chgData name="Olivia Smibert" userId="3a5a476f-fd04-4679-896e-8d98dbcf1ee7" providerId="ADAL" clId="{7381B2A2-7A19-3C46-A8BC-1A28ACF42C30}" dt="2025-03-06T12:41:55.486" v="695" actId="478"/>
          <ac:spMkLst>
            <pc:docMk/>
            <pc:sldMk cId="98051232" sldId="256"/>
            <ac:spMk id="44" creationId="{4367D598-E8A8-B90E-5FDE-34BAAC45DED3}"/>
          </ac:spMkLst>
        </pc:spChg>
        <pc:spChg chg="add mod">
          <ac:chgData name="Olivia Smibert" userId="3a5a476f-fd04-4679-896e-8d98dbcf1ee7" providerId="ADAL" clId="{7381B2A2-7A19-3C46-A8BC-1A28ACF42C30}" dt="2025-03-06T12:45:02.421" v="962" actId="14100"/>
          <ac:spMkLst>
            <pc:docMk/>
            <pc:sldMk cId="98051232" sldId="256"/>
            <ac:spMk id="45" creationId="{E12B1CD3-7E4A-EA40-E102-E578B92E600A}"/>
          </ac:spMkLst>
        </pc:spChg>
        <pc:spChg chg="add mod">
          <ac:chgData name="Olivia Smibert" userId="3a5a476f-fd04-4679-896e-8d98dbcf1ee7" providerId="ADAL" clId="{7381B2A2-7A19-3C46-A8BC-1A28ACF42C30}" dt="2025-03-06T12:50:45.705" v="1176" actId="20577"/>
          <ac:spMkLst>
            <pc:docMk/>
            <pc:sldMk cId="98051232" sldId="256"/>
            <ac:spMk id="46" creationId="{CB2E843F-8808-AE72-6120-98859E135154}"/>
          </ac:spMkLst>
        </pc:spChg>
        <pc:spChg chg="add mod">
          <ac:chgData name="Olivia Smibert" userId="3a5a476f-fd04-4679-896e-8d98dbcf1ee7" providerId="ADAL" clId="{7381B2A2-7A19-3C46-A8BC-1A28ACF42C30}" dt="2025-03-06T12:46:43.172" v="978" actId="14100"/>
          <ac:spMkLst>
            <pc:docMk/>
            <pc:sldMk cId="98051232" sldId="256"/>
            <ac:spMk id="48" creationId="{C88EA3A8-AECD-2D62-3051-F715E7B29FAF}"/>
          </ac:spMkLst>
        </pc:spChg>
        <pc:spChg chg="add mod">
          <ac:chgData name="Olivia Smibert" userId="3a5a476f-fd04-4679-896e-8d98dbcf1ee7" providerId="ADAL" clId="{7381B2A2-7A19-3C46-A8BC-1A28ACF42C30}" dt="2025-03-06T12:51:55.388" v="1222" actId="20577"/>
          <ac:spMkLst>
            <pc:docMk/>
            <pc:sldMk cId="98051232" sldId="256"/>
            <ac:spMk id="49" creationId="{F751F9A9-B0DA-9C3C-7F7F-D139814E243B}"/>
          </ac:spMkLst>
        </pc:spChg>
        <pc:spChg chg="add del">
          <ac:chgData name="Olivia Smibert" userId="3a5a476f-fd04-4679-896e-8d98dbcf1ee7" providerId="ADAL" clId="{7381B2A2-7A19-3C46-A8BC-1A28ACF42C30}" dt="2025-03-06T12:47:02.631" v="985" actId="478"/>
          <ac:spMkLst>
            <pc:docMk/>
            <pc:sldMk cId="98051232" sldId="256"/>
            <ac:spMk id="51" creationId="{005E5A48-BD10-B321-9FBF-4DF2E37FBBA8}"/>
          </ac:spMkLst>
        </pc:spChg>
        <pc:spChg chg="add mod">
          <ac:chgData name="Olivia Smibert" userId="3a5a476f-fd04-4679-896e-8d98dbcf1ee7" providerId="ADAL" clId="{7381B2A2-7A19-3C46-A8BC-1A28ACF42C30}" dt="2025-03-06T12:48:05.474" v="1001" actId="14100"/>
          <ac:spMkLst>
            <pc:docMk/>
            <pc:sldMk cId="98051232" sldId="256"/>
            <ac:spMk id="52" creationId="{2A4350E5-C190-7491-B226-F3DBD7C845B4}"/>
          </ac:spMkLst>
        </pc:spChg>
        <pc:spChg chg="add mod">
          <ac:chgData name="Olivia Smibert" userId="3a5a476f-fd04-4679-896e-8d98dbcf1ee7" providerId="ADAL" clId="{7381B2A2-7A19-3C46-A8BC-1A28ACF42C30}" dt="2025-03-06T12:54:42.431" v="1549" actId="1076"/>
          <ac:spMkLst>
            <pc:docMk/>
            <pc:sldMk cId="98051232" sldId="256"/>
            <ac:spMk id="53" creationId="{2A73F70A-6964-76BD-5173-B82827E85316}"/>
          </ac:spMkLst>
        </pc:spChg>
        <pc:picChg chg="add del mod">
          <ac:chgData name="Olivia Smibert" userId="3a5a476f-fd04-4679-896e-8d98dbcf1ee7" providerId="ADAL" clId="{7381B2A2-7A19-3C46-A8BC-1A28ACF42C30}" dt="2025-03-06T12:19:48.860" v="491" actId="478"/>
          <ac:picMkLst>
            <pc:docMk/>
            <pc:sldMk cId="98051232" sldId="256"/>
            <ac:picMk id="32" creationId="{A227A78A-809D-1B87-6E94-8D7294A86876}"/>
          </ac:picMkLst>
        </pc:picChg>
        <pc:picChg chg="add del mod">
          <ac:chgData name="Olivia Smibert" userId="3a5a476f-fd04-4679-896e-8d98dbcf1ee7" providerId="ADAL" clId="{7381B2A2-7A19-3C46-A8BC-1A28ACF42C30}" dt="2025-03-06T12:41:29.897" v="690" actId="478"/>
          <ac:picMkLst>
            <pc:docMk/>
            <pc:sldMk cId="98051232" sldId="256"/>
            <ac:picMk id="38" creationId="{7AB5DF0E-AADB-6D9E-D0C1-E1CC4EFEA605}"/>
          </ac:picMkLst>
        </pc:picChg>
        <pc:picChg chg="add mod">
          <ac:chgData name="Olivia Smibert" userId="3a5a476f-fd04-4679-896e-8d98dbcf1ee7" providerId="ADAL" clId="{7381B2A2-7A19-3C46-A8BC-1A28ACF42C30}" dt="2025-03-06T12:48:41.362" v="1008" actId="1076"/>
          <ac:picMkLst>
            <pc:docMk/>
            <pc:sldMk cId="98051232" sldId="256"/>
            <ac:picMk id="40" creationId="{9165E86F-788B-4CFC-CACE-554669A539D1}"/>
          </ac:picMkLst>
        </pc:picChg>
        <pc:picChg chg="add del mod">
          <ac:chgData name="Olivia Smibert" userId="3a5a476f-fd04-4679-896e-8d98dbcf1ee7" providerId="ADAL" clId="{7381B2A2-7A19-3C46-A8BC-1A28ACF42C30}" dt="2025-03-06T12:39:09.191" v="593" actId="478"/>
          <ac:picMkLst>
            <pc:docMk/>
            <pc:sldMk cId="98051232" sldId="256"/>
            <ac:picMk id="41" creationId="{51914396-5682-CD94-A6EB-9E562613D293}"/>
          </ac:picMkLst>
        </pc:picChg>
        <pc:picChg chg="del">
          <ac:chgData name="Olivia Smibert" userId="3a5a476f-fd04-4679-896e-8d98dbcf1ee7" providerId="ADAL" clId="{7381B2A2-7A19-3C46-A8BC-1A28ACF42C30}" dt="2025-03-06T12:41:54.423" v="694" actId="478"/>
          <ac:picMkLst>
            <pc:docMk/>
            <pc:sldMk cId="98051232" sldId="256"/>
            <ac:picMk id="43" creationId="{1343B6CC-4C33-6203-7A87-64237882D426}"/>
          </ac:picMkLst>
        </pc:picChg>
        <pc:picChg chg="add mod">
          <ac:chgData name="Olivia Smibert" userId="3a5a476f-fd04-4679-896e-8d98dbcf1ee7" providerId="ADAL" clId="{7381B2A2-7A19-3C46-A8BC-1A28ACF42C30}" dt="2025-03-06T12:48:45.432" v="1010" actId="1076"/>
          <ac:picMkLst>
            <pc:docMk/>
            <pc:sldMk cId="98051232" sldId="256"/>
            <ac:picMk id="47" creationId="{06A7FB43-8CD0-E4A8-9F3D-7265A8154B2C}"/>
          </ac:picMkLst>
        </pc:picChg>
        <pc:picChg chg="add del">
          <ac:chgData name="Olivia Smibert" userId="3a5a476f-fd04-4679-896e-8d98dbcf1ee7" providerId="ADAL" clId="{7381B2A2-7A19-3C46-A8BC-1A28ACF42C30}" dt="2025-03-06T12:12:09.014" v="427" actId="478"/>
          <ac:picMkLst>
            <pc:docMk/>
            <pc:sldMk cId="98051232" sldId="256"/>
            <ac:picMk id="1026" creationId="{A3ABCA73-4E79-A189-F245-9EBFF57DF2E1}"/>
          </ac:picMkLst>
        </pc:picChg>
        <pc:picChg chg="add mod">
          <ac:chgData name="Olivia Smibert" userId="3a5a476f-fd04-4679-896e-8d98dbcf1ee7" providerId="ADAL" clId="{7381B2A2-7A19-3C46-A8BC-1A28ACF42C30}" dt="2025-03-06T12:20:05.612" v="495" actId="1076"/>
          <ac:picMkLst>
            <pc:docMk/>
            <pc:sldMk cId="98051232" sldId="256"/>
            <ac:picMk id="1028" creationId="{47CBD951-533E-4B93-C2E3-71D454368D50}"/>
          </ac:picMkLst>
        </pc:picChg>
        <pc:picChg chg="add del mod">
          <ac:chgData name="Olivia Smibert" userId="3a5a476f-fd04-4679-896e-8d98dbcf1ee7" providerId="ADAL" clId="{7381B2A2-7A19-3C46-A8BC-1A28ACF42C30}" dt="2025-03-06T12:18:59.306" v="474" actId="478"/>
          <ac:picMkLst>
            <pc:docMk/>
            <pc:sldMk cId="98051232" sldId="256"/>
            <ac:picMk id="1030" creationId="{A7D0F65B-3B93-7E62-8BC4-3562D8052904}"/>
          </ac:picMkLst>
        </pc:picChg>
        <pc:picChg chg="add del mod">
          <ac:chgData name="Olivia Smibert" userId="3a5a476f-fd04-4679-896e-8d98dbcf1ee7" providerId="ADAL" clId="{7381B2A2-7A19-3C46-A8BC-1A28ACF42C30}" dt="2025-03-06T12:17:51.822" v="467" actId="478"/>
          <ac:picMkLst>
            <pc:docMk/>
            <pc:sldMk cId="98051232" sldId="256"/>
            <ac:picMk id="1032" creationId="{1D2ACBFB-860C-0F5F-98B7-9F43EFF6C9F5}"/>
          </ac:picMkLst>
        </pc:picChg>
        <pc:picChg chg="add del mod">
          <ac:chgData name="Olivia Smibert" userId="3a5a476f-fd04-4679-896e-8d98dbcf1ee7" providerId="ADAL" clId="{7381B2A2-7A19-3C46-A8BC-1A28ACF42C30}" dt="2025-03-06T12:17:30.228" v="460" actId="1076"/>
          <ac:picMkLst>
            <pc:docMk/>
            <pc:sldMk cId="98051232" sldId="256"/>
            <ac:picMk id="1034" creationId="{763A3CFF-9B64-C7CF-7F73-9B68F05BD77F}"/>
          </ac:picMkLst>
        </pc:picChg>
        <pc:picChg chg="add mod">
          <ac:chgData name="Olivia Smibert" userId="3a5a476f-fd04-4679-896e-8d98dbcf1ee7" providerId="ADAL" clId="{7381B2A2-7A19-3C46-A8BC-1A28ACF42C30}" dt="2025-03-06T12:21:37.935" v="546" actId="1076"/>
          <ac:picMkLst>
            <pc:docMk/>
            <pc:sldMk cId="98051232" sldId="256"/>
            <ac:picMk id="1036" creationId="{035DE2E5-9D13-AD48-3274-746B106D5468}"/>
          </ac:picMkLst>
        </pc:picChg>
        <pc:picChg chg="add mod">
          <ac:chgData name="Olivia Smibert" userId="3a5a476f-fd04-4679-896e-8d98dbcf1ee7" providerId="ADAL" clId="{7381B2A2-7A19-3C46-A8BC-1A28ACF42C30}" dt="2025-03-06T12:19:05.415" v="477" actId="1076"/>
          <ac:picMkLst>
            <pc:docMk/>
            <pc:sldMk cId="98051232" sldId="256"/>
            <ac:picMk id="1038" creationId="{8A5058D3-9C2B-6A5A-5A9D-95BA7A0C990C}"/>
          </ac:picMkLst>
        </pc:picChg>
        <pc:picChg chg="add mod">
          <ac:chgData name="Olivia Smibert" userId="3a5a476f-fd04-4679-896e-8d98dbcf1ee7" providerId="ADAL" clId="{7381B2A2-7A19-3C46-A8BC-1A28ACF42C30}" dt="2025-03-06T12:48:49.768" v="1011" actId="14100"/>
          <ac:picMkLst>
            <pc:docMk/>
            <pc:sldMk cId="98051232" sldId="256"/>
            <ac:picMk id="1040" creationId="{5AF21DB7-4621-10DC-DE76-69C5278C6654}"/>
          </ac:picMkLst>
        </pc:picChg>
        <pc:picChg chg="add mod">
          <ac:chgData name="Olivia Smibert" userId="3a5a476f-fd04-4679-896e-8d98dbcf1ee7" providerId="ADAL" clId="{7381B2A2-7A19-3C46-A8BC-1A28ACF42C30}" dt="2025-03-06T12:40:20.887" v="607" actId="1076"/>
          <ac:picMkLst>
            <pc:docMk/>
            <pc:sldMk cId="98051232" sldId="256"/>
            <ac:picMk id="1042" creationId="{A7BF993A-97C4-51E2-A654-005C131032E0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B0934A-73F7-1F4D-8E48-3E4A6021BA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F5CDD2B-C91F-C94C-859A-713BFC4DD1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91ED89-A522-574C-BEF6-23952F3B4B57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3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6863A7-7AEA-9B47-919A-F8290FDF75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907878-B1BF-934B-B3EE-C0F2BF7722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39624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16CE03-BAB6-DF4C-8DDE-EDF8B40D5F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1739278-2F15-C545-AAAE-F43E2A6854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2E6775-CD32-3142-8FBA-CDFB263F3F2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3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61732B-9114-794D-A840-56608EFFA3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87E824-670B-F54F-B320-0C9D58D344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0066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A98D59E-1E91-6442-B486-69DCB6DED4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C48020-99DE-034A-896B-B168AFB238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B4BD8C-E04E-344D-BCA3-4A12AF9F9FD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3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22BA77-B54E-294B-8E51-618E05266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87FCA8-BA90-3541-B0B2-65F59CAACB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543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11FE32-5B64-E243-9843-A1EA2051C3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68202A-F2E5-FC45-ACF7-E80F6D7F88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4E0E2A-40A9-9E49-9929-3C392D31873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3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FC6A75-50A7-FD48-9F8D-FB2C39DA3A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3C649F-74CE-F84F-B801-BA6564F4E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93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C92EFB-E534-0B42-82B0-D66CA3A688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ED4610-C5DA-DD4F-87FA-011B5B738A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9B7977-8B5A-5F4D-A953-66956B975D5E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3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9D024F-74DA-F747-9F3F-12FC385748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B084D1-6F99-7B4A-86C4-626B3DBD42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964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EB8CA2-0484-E046-B109-39812C272F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398EB0-FE7C-194F-ADF9-152ECCB3958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031F7A-AE90-1B46-AE9B-15C84FAB35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1FA71C-8983-674C-A8D8-7A92D4E77443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3/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CCBC2C-F5E8-8B44-AAF8-57C9F683B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138B94-9D6F-7649-A1CE-5DF2873EAA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4855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4A7FB-656F-2D44-BF6D-9A6296F5C5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ED082F-CF7B-6640-B0DD-47812C442D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7A971E-FD89-D045-859D-668111E877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97CA272-0B40-1C4C-8651-B6B649E82C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BA28564-A83D-3D41-9326-EE04008E1C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26F9878-94A7-D440-9A77-51A1EA8F785D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3/7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13572D8-65D0-A74D-9157-DA78839BAC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367A03D-FD78-174E-A057-4CDF5DE3C8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5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B3D4D0-427F-3644-AE9F-7F9F02C8FE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A6876D9-D8F4-3E46-AD79-3F1CA5075968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3/7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4D88B33-B404-7D49-8C6E-72E7BEE548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4BF84DA-594E-BF46-A0F9-E98ECA299D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2033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C642915-FDC1-FB40-B2EA-C81621B13A4E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3/7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1282C27-207A-D143-B2F5-5ACDD3A0A9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363BDB4-97C0-664F-82A9-FDEED8DC8B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0744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B6FD49-22F7-6342-8EB6-58DC854D98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738B74-02DD-4E41-B862-2E393D02CC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763CE6A-13AB-674E-94BC-02C05CBD26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D367F2-1863-8745-B0C0-223C48254926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3/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2BA1F2-4205-3B42-9CA2-608CF7CB1D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671325-42DD-9D4C-BA1C-C3F3E0481E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99702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737B78-070F-F345-B4F5-2CD85DB00F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73A062D-BBBC-9E4F-BB12-301E15D789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5B13057-E866-B245-8719-C8F338C3C0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D9CA1E-011F-874B-B115-68686FE8F4EC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3/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22A0C4-99AA-1345-9159-65D57E98C6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17377B-6239-5143-A68F-90A23176B5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895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5">
            <a:lumMod val="20000"/>
            <a:lumOff val="8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844040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emf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>
            <a:extLst>
              <a:ext uri="{FF2B5EF4-FFF2-40B4-BE49-F238E27FC236}">
                <a16:creationId xmlns:a16="http://schemas.microsoft.com/office/drawing/2014/main" id="{F0DEE156-89C7-FF43-991B-3DD24BD32D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-25894"/>
            <a:ext cx="12192000" cy="707886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F548E9D6-92B2-D44D-BBCE-51953A30C681}"/>
              </a:ext>
            </a:extLst>
          </p:cNvPr>
          <p:cNvSpPr/>
          <p:nvPr/>
        </p:nvSpPr>
        <p:spPr>
          <a:xfrm>
            <a:off x="0" y="683179"/>
            <a:ext cx="12192000" cy="231227"/>
          </a:xfrm>
          <a:prstGeom prst="rect">
            <a:avLst/>
          </a:prstGeom>
          <a:solidFill>
            <a:srgbClr val="343D52"/>
          </a:solidFill>
          <a:ln>
            <a:solidFill>
              <a:srgbClr val="354F5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 dirty="0">
                <a:solidFill>
                  <a:schemeClr val="bg1"/>
                </a:solidFill>
              </a:rPr>
              <a:t>           @</a:t>
            </a:r>
            <a:r>
              <a:rPr lang="en-US" sz="1200" dirty="0" err="1">
                <a:solidFill>
                  <a:schemeClr val="bg1"/>
                </a:solidFill>
              </a:rPr>
              <a:t>TheTxIDJournal</a:t>
            </a:r>
            <a:r>
              <a:rPr lang="en-US" sz="1200" dirty="0">
                <a:solidFill>
                  <a:schemeClr val="bg1"/>
                </a:solidFill>
              </a:rPr>
              <a:t>  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23CCF476-319F-8140-A593-7D3D0C061C4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4854" y="668975"/>
            <a:ext cx="276606" cy="276606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492131EC-6391-3144-8E00-5CE130B4CE5F}"/>
              </a:ext>
            </a:extLst>
          </p:cNvPr>
          <p:cNvSpPr txBox="1"/>
          <p:nvPr/>
        </p:nvSpPr>
        <p:spPr>
          <a:xfrm>
            <a:off x="8616989" y="660292"/>
            <a:ext cx="34871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solidFill>
                  <a:schemeClr val="bg1"/>
                </a:solidFill>
              </a:rPr>
              <a:t>Smibert</a:t>
            </a:r>
            <a:r>
              <a:rPr lang="en-US" sz="1200" dirty="0">
                <a:solidFill>
                  <a:schemeClr val="bg1"/>
                </a:solidFill>
              </a:rPr>
              <a:t> </a:t>
            </a:r>
            <a:r>
              <a:rPr lang="en-US" sz="1200" i="1" dirty="0">
                <a:solidFill>
                  <a:schemeClr val="bg1"/>
                </a:solidFill>
              </a:rPr>
              <a:t>et al</a:t>
            </a:r>
            <a:r>
              <a:rPr lang="en-US" sz="1200" dirty="0">
                <a:solidFill>
                  <a:schemeClr val="bg1"/>
                </a:solidFill>
              </a:rPr>
              <a:t>.  </a:t>
            </a:r>
            <a:r>
              <a:rPr lang="en-US" sz="1200" b="1" i="1" dirty="0">
                <a:solidFill>
                  <a:schemeClr val="bg1"/>
                </a:solidFill>
              </a:rPr>
              <a:t>Transplant Infectious Diseases</a:t>
            </a:r>
            <a:r>
              <a:rPr lang="en-US" sz="1200" dirty="0">
                <a:solidFill>
                  <a:schemeClr val="bg1"/>
                </a:solidFill>
              </a:rPr>
              <a:t>.  2025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1A0D7E5-0BBB-AD44-B806-57C0B508F8D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6073352"/>
            <a:ext cx="12271830" cy="93620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7FD39CF-48BE-F043-9CA6-1EA6F45D25E8}"/>
              </a:ext>
            </a:extLst>
          </p:cNvPr>
          <p:cNvSpPr txBox="1"/>
          <p:nvPr/>
        </p:nvSpPr>
        <p:spPr>
          <a:xfrm>
            <a:off x="-28908" y="-99137"/>
            <a:ext cx="121920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2200" kern="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tibiotic exposure and risk of allograft rejection and survival after liver transplant (</a:t>
            </a:r>
            <a:r>
              <a:rPr lang="en-AU" sz="2200" kern="0" dirty="0" err="1">
                <a:solidFill>
                  <a:schemeClr val="bg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LTx</a:t>
            </a:r>
            <a:r>
              <a:rPr lang="en-AU" sz="2200" kern="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: an observational cohort study from a tertiary referral centre</a:t>
            </a:r>
            <a:r>
              <a:rPr lang="en-AU" sz="2200" dirty="0">
                <a:solidFill>
                  <a:schemeClr val="bg1"/>
                </a:solidFill>
                <a:effectLst/>
              </a:rPr>
              <a:t> </a:t>
            </a:r>
            <a:endParaRPr lang="en-US" sz="2200" b="1" dirty="0">
              <a:solidFill>
                <a:schemeClr val="bg1"/>
              </a:solidFill>
            </a:endParaRP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366636D0-BF84-4A1A-9E37-3446B179CF50}"/>
              </a:ext>
            </a:extLst>
          </p:cNvPr>
          <p:cNvCxnSpPr/>
          <p:nvPr/>
        </p:nvCxnSpPr>
        <p:spPr>
          <a:xfrm>
            <a:off x="0" y="639744"/>
            <a:ext cx="12192000" cy="0"/>
          </a:xfrm>
          <a:prstGeom prst="line">
            <a:avLst/>
          </a:prstGeom>
          <a:ln w="76200">
            <a:solidFill>
              <a:srgbClr val="39B88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Off-page Connector 16">
            <a:extLst>
              <a:ext uri="{FF2B5EF4-FFF2-40B4-BE49-F238E27FC236}">
                <a16:creationId xmlns:a16="http://schemas.microsoft.com/office/drawing/2014/main" id="{D9141940-3562-BD18-FFC6-F74D7BD9D4E3}"/>
              </a:ext>
            </a:extLst>
          </p:cNvPr>
          <p:cNvSpPr/>
          <p:nvPr/>
        </p:nvSpPr>
        <p:spPr>
          <a:xfrm>
            <a:off x="110168" y="959783"/>
            <a:ext cx="3877938" cy="747624"/>
          </a:xfrm>
          <a:prstGeom prst="flowChartOffpageConnector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2400" dirty="0"/>
              <a:t>SETTING AND SUBJECTS</a:t>
            </a:r>
          </a:p>
        </p:txBody>
      </p:sp>
      <p:sp>
        <p:nvSpPr>
          <p:cNvPr id="21" name="Off-page Connector 20">
            <a:extLst>
              <a:ext uri="{FF2B5EF4-FFF2-40B4-BE49-F238E27FC236}">
                <a16:creationId xmlns:a16="http://schemas.microsoft.com/office/drawing/2014/main" id="{AEB703E2-2E56-5A2E-9895-9E006E9262FD}"/>
              </a:ext>
            </a:extLst>
          </p:cNvPr>
          <p:cNvSpPr/>
          <p:nvPr/>
        </p:nvSpPr>
        <p:spPr>
          <a:xfrm>
            <a:off x="4074404" y="959783"/>
            <a:ext cx="3877938" cy="747624"/>
          </a:xfrm>
          <a:prstGeom prst="flowChartOffpageConnector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2400" dirty="0"/>
              <a:t>OUTCOMES</a:t>
            </a:r>
          </a:p>
        </p:txBody>
      </p:sp>
      <p:sp>
        <p:nvSpPr>
          <p:cNvPr id="22" name="Off-page Connector 21">
            <a:extLst>
              <a:ext uri="{FF2B5EF4-FFF2-40B4-BE49-F238E27FC236}">
                <a16:creationId xmlns:a16="http://schemas.microsoft.com/office/drawing/2014/main" id="{78F022BA-B0D8-2485-C948-289D98B3E501}"/>
              </a:ext>
            </a:extLst>
          </p:cNvPr>
          <p:cNvSpPr/>
          <p:nvPr/>
        </p:nvSpPr>
        <p:spPr>
          <a:xfrm>
            <a:off x="8089207" y="959783"/>
            <a:ext cx="4014889" cy="747624"/>
          </a:xfrm>
          <a:prstGeom prst="flowChartOffpageConnector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2400" dirty="0"/>
              <a:t>CONCLUSIONS</a:t>
            </a:r>
          </a:p>
        </p:txBody>
      </p:sp>
      <p:sp>
        <p:nvSpPr>
          <p:cNvPr id="23" name="Rounded Rectangle 22">
            <a:extLst>
              <a:ext uri="{FF2B5EF4-FFF2-40B4-BE49-F238E27FC236}">
                <a16:creationId xmlns:a16="http://schemas.microsoft.com/office/drawing/2014/main" id="{5FD14A22-A1D7-4FAB-5CA2-C6D764E4A793}"/>
              </a:ext>
            </a:extLst>
          </p:cNvPr>
          <p:cNvSpPr/>
          <p:nvPr/>
        </p:nvSpPr>
        <p:spPr>
          <a:xfrm>
            <a:off x="67019" y="1775590"/>
            <a:ext cx="3964236" cy="1025416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>
              <a:solidFill>
                <a:schemeClr val="tx1"/>
              </a:solidFill>
            </a:endParaRPr>
          </a:p>
        </p:txBody>
      </p:sp>
      <p:sp>
        <p:nvSpPr>
          <p:cNvPr id="24" name="Rounded Rectangle 23">
            <a:extLst>
              <a:ext uri="{FF2B5EF4-FFF2-40B4-BE49-F238E27FC236}">
                <a16:creationId xmlns:a16="http://schemas.microsoft.com/office/drawing/2014/main" id="{B4F1A0A9-1E57-415D-D4EB-3B73172FFA4E}"/>
              </a:ext>
            </a:extLst>
          </p:cNvPr>
          <p:cNvSpPr/>
          <p:nvPr/>
        </p:nvSpPr>
        <p:spPr>
          <a:xfrm>
            <a:off x="97976" y="2890407"/>
            <a:ext cx="3976428" cy="1102181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>
              <a:solidFill>
                <a:schemeClr val="tx1"/>
              </a:solidFill>
            </a:endParaRPr>
          </a:p>
        </p:txBody>
      </p:sp>
      <p:sp>
        <p:nvSpPr>
          <p:cNvPr id="25" name="Rounded Rectangle 24">
            <a:extLst>
              <a:ext uri="{FF2B5EF4-FFF2-40B4-BE49-F238E27FC236}">
                <a16:creationId xmlns:a16="http://schemas.microsoft.com/office/drawing/2014/main" id="{06D28810-CF13-8315-51F1-7C5C7971EAC7}"/>
              </a:ext>
            </a:extLst>
          </p:cNvPr>
          <p:cNvSpPr/>
          <p:nvPr/>
        </p:nvSpPr>
        <p:spPr>
          <a:xfrm>
            <a:off x="110168" y="4830775"/>
            <a:ext cx="3976428" cy="1200330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dirty="0">
              <a:solidFill>
                <a:schemeClr val="tx1"/>
              </a:solidFill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1DAB825-7476-4D47-7934-E4B49FB16C96}"/>
              </a:ext>
            </a:extLst>
          </p:cNvPr>
          <p:cNvSpPr txBox="1"/>
          <p:nvPr/>
        </p:nvSpPr>
        <p:spPr>
          <a:xfrm>
            <a:off x="110168" y="1822012"/>
            <a:ext cx="329343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solidFill>
                  <a:schemeClr val="tx1"/>
                </a:solidFill>
              </a:rPr>
              <a:t>Antibiotics may damage the gut microbiota and this may in turn, impact outcomes following </a:t>
            </a:r>
            <a:r>
              <a:rPr lang="en-AU" dirty="0" err="1">
                <a:solidFill>
                  <a:schemeClr val="tx1"/>
                </a:solidFill>
              </a:rPr>
              <a:t>LTx</a:t>
            </a:r>
            <a:endParaRPr lang="en-AU" dirty="0">
              <a:solidFill>
                <a:schemeClr val="tx1"/>
              </a:solidFill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0B4E0FD-4159-7794-0E7E-A16AA7FA4E42}"/>
              </a:ext>
            </a:extLst>
          </p:cNvPr>
          <p:cNvSpPr txBox="1"/>
          <p:nvPr/>
        </p:nvSpPr>
        <p:spPr>
          <a:xfrm>
            <a:off x="110168" y="4963028"/>
            <a:ext cx="315513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solidFill>
                  <a:schemeClr val="tx1"/>
                </a:solidFill>
              </a:rPr>
              <a:t>Detailed data on antibiotic exposures 30-day prior to and during 1-year post </a:t>
            </a:r>
            <a:r>
              <a:rPr lang="en-AU" dirty="0" err="1">
                <a:solidFill>
                  <a:schemeClr val="tx1"/>
                </a:solidFill>
              </a:rPr>
              <a:t>LTx</a:t>
            </a:r>
            <a:endParaRPr lang="en-AU" dirty="0">
              <a:solidFill>
                <a:schemeClr val="tx1"/>
              </a:solidFill>
            </a:endParaRPr>
          </a:p>
          <a:p>
            <a:endParaRPr lang="en-AU" dirty="0"/>
          </a:p>
        </p:txBody>
      </p:sp>
      <p:pic>
        <p:nvPicPr>
          <p:cNvPr id="1028" name="Picture 4" descr="Hospital Icons PNG Images | 65000+ Vector Icon Packs | Free Download On  Pngtree">
            <a:extLst>
              <a:ext uri="{FF2B5EF4-FFF2-40B4-BE49-F238E27FC236}">
                <a16:creationId xmlns:a16="http://schemas.microsoft.com/office/drawing/2014/main" id="{47CBD951-533E-4B93-C2E3-71D454368D5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62624" y="2945965"/>
            <a:ext cx="904225" cy="9042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10F4F2D7-E84F-AD67-57B9-20AAE1242EBB}"/>
              </a:ext>
            </a:extLst>
          </p:cNvPr>
          <p:cNvSpPr txBox="1"/>
          <p:nvPr/>
        </p:nvSpPr>
        <p:spPr>
          <a:xfrm>
            <a:off x="97976" y="3009899"/>
            <a:ext cx="314394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solidFill>
                  <a:schemeClr val="tx1"/>
                </a:solidFill>
              </a:rPr>
              <a:t>Retrospective Cohort Study: Multi-State Liver Transplant (</a:t>
            </a:r>
            <a:r>
              <a:rPr lang="en-AU" dirty="0" err="1">
                <a:solidFill>
                  <a:schemeClr val="tx1"/>
                </a:solidFill>
              </a:rPr>
              <a:t>LTx</a:t>
            </a:r>
            <a:r>
              <a:rPr lang="en-AU" dirty="0">
                <a:solidFill>
                  <a:schemeClr val="tx1"/>
                </a:solidFill>
              </a:rPr>
              <a:t>) Centre, Australia</a:t>
            </a:r>
          </a:p>
          <a:p>
            <a:endParaRPr lang="en-AU" dirty="0"/>
          </a:p>
        </p:txBody>
      </p:sp>
      <p:pic>
        <p:nvPicPr>
          <p:cNvPr id="1036" name="Picture 12" descr="Antibiotic pill jar icon, simple style 14595998 Vector Art at Vecteezy">
            <a:extLst>
              <a:ext uri="{FF2B5EF4-FFF2-40B4-BE49-F238E27FC236}">
                <a16:creationId xmlns:a16="http://schemas.microsoft.com/office/drawing/2014/main" id="{035DE2E5-9D13-AD48-3274-746B106D546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64" r="16519"/>
          <a:stretch/>
        </p:blipFill>
        <p:spPr bwMode="auto">
          <a:xfrm>
            <a:off x="3309840" y="4912997"/>
            <a:ext cx="626169" cy="9750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8" name="Picture 14" descr="Gut microbiome line black icon. Intestine microbiota. Sign f | Colourbox">
            <a:extLst>
              <a:ext uri="{FF2B5EF4-FFF2-40B4-BE49-F238E27FC236}">
                <a16:creationId xmlns:a16="http://schemas.microsoft.com/office/drawing/2014/main" id="{8A5058D3-9C2B-6A5A-5A9D-95BA7A0C990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03" t="10842" r="10740" b="11442"/>
          <a:stretch/>
        </p:blipFill>
        <p:spPr bwMode="auto">
          <a:xfrm>
            <a:off x="3265298" y="1878991"/>
            <a:ext cx="739638" cy="7421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0" name="Rounded Rectangle 29">
            <a:extLst>
              <a:ext uri="{FF2B5EF4-FFF2-40B4-BE49-F238E27FC236}">
                <a16:creationId xmlns:a16="http://schemas.microsoft.com/office/drawing/2014/main" id="{573B431C-4AE0-895A-0B52-02E6B7E1AE6F}"/>
              </a:ext>
            </a:extLst>
          </p:cNvPr>
          <p:cNvSpPr/>
          <p:nvPr/>
        </p:nvSpPr>
        <p:spPr>
          <a:xfrm>
            <a:off x="110168" y="4068701"/>
            <a:ext cx="3976428" cy="683233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dirty="0">
              <a:solidFill>
                <a:schemeClr val="tx1"/>
              </a:solidFill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D703F090-72E4-76A8-067D-05D1A4C73A78}"/>
              </a:ext>
            </a:extLst>
          </p:cNvPr>
          <p:cNvSpPr txBox="1"/>
          <p:nvPr/>
        </p:nvSpPr>
        <p:spPr>
          <a:xfrm>
            <a:off x="154710" y="4212334"/>
            <a:ext cx="31551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January 2017 – June 2022</a:t>
            </a:r>
          </a:p>
        </p:txBody>
      </p:sp>
      <p:pic>
        <p:nvPicPr>
          <p:cNvPr id="1040" name="Picture 16" descr="Simple Round Clock Rotating Arrow Animation Stock Footage Video (100%  Royalty-free) 3438514307 | Shutterstock">
            <a:extLst>
              <a:ext uri="{FF2B5EF4-FFF2-40B4-BE49-F238E27FC236}">
                <a16:creationId xmlns:a16="http://schemas.microsoft.com/office/drawing/2014/main" id="{5AF21DB7-4621-10DC-DE76-69C5278C665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000" t="11343" r="28749" b="11419"/>
          <a:stretch/>
        </p:blipFill>
        <p:spPr bwMode="auto">
          <a:xfrm>
            <a:off x="3309840" y="4085099"/>
            <a:ext cx="626169" cy="6595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3" name="Rounded Rectangle 32">
            <a:extLst>
              <a:ext uri="{FF2B5EF4-FFF2-40B4-BE49-F238E27FC236}">
                <a16:creationId xmlns:a16="http://schemas.microsoft.com/office/drawing/2014/main" id="{DDF84AE8-A076-1940-998C-6485E8E29A08}"/>
              </a:ext>
            </a:extLst>
          </p:cNvPr>
          <p:cNvSpPr/>
          <p:nvPr/>
        </p:nvSpPr>
        <p:spPr>
          <a:xfrm>
            <a:off x="4105576" y="1775590"/>
            <a:ext cx="3964236" cy="1025416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>
              <a:solidFill>
                <a:schemeClr val="tx1"/>
              </a:solidFill>
            </a:endParaRPr>
          </a:p>
        </p:txBody>
      </p:sp>
      <p:sp>
        <p:nvSpPr>
          <p:cNvPr id="35" name="Rounded Rectangle 34">
            <a:extLst>
              <a:ext uri="{FF2B5EF4-FFF2-40B4-BE49-F238E27FC236}">
                <a16:creationId xmlns:a16="http://schemas.microsoft.com/office/drawing/2014/main" id="{711A303D-F64B-608B-785C-4943300DC2AC}"/>
              </a:ext>
            </a:extLst>
          </p:cNvPr>
          <p:cNvSpPr/>
          <p:nvPr/>
        </p:nvSpPr>
        <p:spPr>
          <a:xfrm>
            <a:off x="4125366" y="2866028"/>
            <a:ext cx="3976428" cy="1586914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dirty="0">
              <a:solidFill>
                <a:schemeClr val="tx1"/>
              </a:solidFill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77ACCA1-0D18-F86B-A4F8-C15885BCF921}"/>
              </a:ext>
            </a:extLst>
          </p:cNvPr>
          <p:cNvSpPr txBox="1"/>
          <p:nvPr/>
        </p:nvSpPr>
        <p:spPr>
          <a:xfrm>
            <a:off x="3839436" y="2084877"/>
            <a:ext cx="32934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2000" dirty="0">
                <a:solidFill>
                  <a:schemeClr val="tx1"/>
                </a:solidFill>
              </a:rPr>
              <a:t>465 patients underwent </a:t>
            </a:r>
            <a:r>
              <a:rPr lang="en-AU" sz="2000" dirty="0" err="1">
                <a:solidFill>
                  <a:schemeClr val="tx1"/>
                </a:solidFill>
              </a:rPr>
              <a:t>LTx</a:t>
            </a:r>
            <a:endParaRPr lang="en-AU" sz="2000" dirty="0">
              <a:solidFill>
                <a:schemeClr val="tx1"/>
              </a:solidFill>
            </a:endParaRPr>
          </a:p>
        </p:txBody>
      </p:sp>
      <p:pic>
        <p:nvPicPr>
          <p:cNvPr id="40" name="Picture 12" descr="Antibiotic pill jar icon, simple style 14595998 Vector Art at Vecteezy">
            <a:extLst>
              <a:ext uri="{FF2B5EF4-FFF2-40B4-BE49-F238E27FC236}">
                <a16:creationId xmlns:a16="http://schemas.microsoft.com/office/drawing/2014/main" id="{9165E86F-788B-4CFC-CACE-554669A539D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64" r="16519"/>
          <a:stretch/>
        </p:blipFill>
        <p:spPr bwMode="auto">
          <a:xfrm>
            <a:off x="7413294" y="2999598"/>
            <a:ext cx="626169" cy="9750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E687DFCA-74D2-A527-D73B-1A375D6FD194}"/>
              </a:ext>
            </a:extLst>
          </p:cNvPr>
          <p:cNvSpPr txBox="1"/>
          <p:nvPr/>
        </p:nvSpPr>
        <p:spPr>
          <a:xfrm>
            <a:off x="4183658" y="3020078"/>
            <a:ext cx="350668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000" dirty="0"/>
              <a:t>Reduced 1-year survival in those exposed to anaerobe-targeting antibiotics &gt;14 days pre (p=.055) or post-LT (p=.040)</a:t>
            </a:r>
          </a:p>
        </p:txBody>
      </p:sp>
      <p:pic>
        <p:nvPicPr>
          <p:cNvPr id="1042" name="Picture 18" descr="Liver icon on white background Royalty Free Vector Image">
            <a:extLst>
              <a:ext uri="{FF2B5EF4-FFF2-40B4-BE49-F238E27FC236}">
                <a16:creationId xmlns:a16="http://schemas.microsoft.com/office/drawing/2014/main" id="{A7BF993A-97C4-51E2-A654-005C131032E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00" t="17593" r="12600" b="23780"/>
          <a:stretch/>
        </p:blipFill>
        <p:spPr bwMode="auto">
          <a:xfrm>
            <a:off x="7073004" y="1944447"/>
            <a:ext cx="909746" cy="76194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5" name="Rounded Rectangle 44">
            <a:extLst>
              <a:ext uri="{FF2B5EF4-FFF2-40B4-BE49-F238E27FC236}">
                <a16:creationId xmlns:a16="http://schemas.microsoft.com/office/drawing/2014/main" id="{E12B1CD3-7E4A-EA40-E102-E578B92E600A}"/>
              </a:ext>
            </a:extLst>
          </p:cNvPr>
          <p:cNvSpPr/>
          <p:nvPr/>
        </p:nvSpPr>
        <p:spPr>
          <a:xfrm>
            <a:off x="4154512" y="4511334"/>
            <a:ext cx="3976428" cy="1503626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dirty="0">
              <a:solidFill>
                <a:schemeClr val="tx1"/>
              </a:solidFill>
            </a:endParaRPr>
          </a:p>
        </p:txBody>
      </p:sp>
      <p:pic>
        <p:nvPicPr>
          <p:cNvPr id="47" name="Picture 12" descr="Antibiotic pill jar icon, simple style 14595998 Vector Art at Vecteezy">
            <a:extLst>
              <a:ext uri="{FF2B5EF4-FFF2-40B4-BE49-F238E27FC236}">
                <a16:creationId xmlns:a16="http://schemas.microsoft.com/office/drawing/2014/main" id="{06A7FB43-8CD0-E4A8-9F3D-7265A8154B2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64" r="16519"/>
          <a:stretch/>
        </p:blipFill>
        <p:spPr bwMode="auto">
          <a:xfrm>
            <a:off x="7445863" y="4802495"/>
            <a:ext cx="626169" cy="9750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CB2E843F-8808-AE72-6120-98859E135154}"/>
              </a:ext>
            </a:extLst>
          </p:cNvPr>
          <p:cNvSpPr txBox="1"/>
          <p:nvPr/>
        </p:nvSpPr>
        <p:spPr>
          <a:xfrm>
            <a:off x="4183658" y="4634052"/>
            <a:ext cx="3363888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000" dirty="0"/>
              <a:t>Increased rejection in those exposed to any duration of anaerobe-targeting antibiotic post-LT (p=.001)</a:t>
            </a:r>
          </a:p>
        </p:txBody>
      </p:sp>
      <p:sp>
        <p:nvSpPr>
          <p:cNvPr id="48" name="Rounded Rectangle 47">
            <a:extLst>
              <a:ext uri="{FF2B5EF4-FFF2-40B4-BE49-F238E27FC236}">
                <a16:creationId xmlns:a16="http://schemas.microsoft.com/office/drawing/2014/main" id="{C88EA3A8-AECD-2D62-3051-F715E7B29FAF}"/>
              </a:ext>
            </a:extLst>
          </p:cNvPr>
          <p:cNvSpPr/>
          <p:nvPr/>
        </p:nvSpPr>
        <p:spPr>
          <a:xfrm>
            <a:off x="8160745" y="1787582"/>
            <a:ext cx="3964236" cy="2204999"/>
          </a:xfrm>
          <a:prstGeom prst="roundRect">
            <a:avLst/>
          </a:prstGeom>
          <a:solidFill>
            <a:srgbClr val="00B05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>
              <a:solidFill>
                <a:schemeClr val="tx1"/>
              </a:solidFill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F751F9A9-B0DA-9C3C-7F7F-D139814E243B}"/>
              </a:ext>
            </a:extLst>
          </p:cNvPr>
          <p:cNvSpPr txBox="1"/>
          <p:nvPr/>
        </p:nvSpPr>
        <p:spPr>
          <a:xfrm>
            <a:off x="8120774" y="1892659"/>
            <a:ext cx="4014888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kern="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Exposure to </a:t>
            </a:r>
            <a:r>
              <a:rPr lang="en-US" sz="2400" b="1" kern="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anaerobic spectrum antibiotics </a:t>
            </a:r>
            <a:r>
              <a:rPr lang="en-US" sz="2400" kern="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before or after </a:t>
            </a:r>
            <a:r>
              <a:rPr lang="en-US" sz="2400" kern="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LTx</a:t>
            </a:r>
            <a:r>
              <a:rPr lang="en-US" sz="2400" kern="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are an independent risk for </a:t>
            </a:r>
            <a:r>
              <a:rPr lang="en-US" sz="2400" b="1" kern="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oor outcomes</a:t>
            </a:r>
            <a:r>
              <a:rPr lang="en-US" sz="2400" kern="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during the first-year post-transplant </a:t>
            </a:r>
            <a:endParaRPr lang="en-AU" sz="2800" dirty="0">
              <a:solidFill>
                <a:schemeClr val="tx1"/>
              </a:solidFill>
            </a:endParaRPr>
          </a:p>
        </p:txBody>
      </p:sp>
      <p:sp>
        <p:nvSpPr>
          <p:cNvPr id="52" name="Rounded Rectangle 51">
            <a:extLst>
              <a:ext uri="{FF2B5EF4-FFF2-40B4-BE49-F238E27FC236}">
                <a16:creationId xmlns:a16="http://schemas.microsoft.com/office/drawing/2014/main" id="{2A4350E5-C190-7491-B226-F3DBD7C845B4}"/>
              </a:ext>
            </a:extLst>
          </p:cNvPr>
          <p:cNvSpPr/>
          <p:nvPr/>
        </p:nvSpPr>
        <p:spPr>
          <a:xfrm>
            <a:off x="8198856" y="4106312"/>
            <a:ext cx="3964236" cy="1908648"/>
          </a:xfrm>
          <a:prstGeom prst="roundRect">
            <a:avLst/>
          </a:prstGeom>
          <a:solidFill>
            <a:srgbClr val="00B05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>
              <a:solidFill>
                <a:schemeClr val="tx1"/>
              </a:solidFill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2A73F70A-6964-76BD-5173-B82827E85316}"/>
              </a:ext>
            </a:extLst>
          </p:cNvPr>
          <p:cNvSpPr txBox="1"/>
          <p:nvPr/>
        </p:nvSpPr>
        <p:spPr>
          <a:xfrm>
            <a:off x="8101794" y="4250138"/>
            <a:ext cx="4107183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kern="0" dirty="0">
                <a:solidFill>
                  <a:schemeClr val="tx1"/>
                </a:solidFill>
                <a:latin typeface="Calibri" panose="020F0502020204030204" pitchFamily="34" charset="0"/>
              </a:rPr>
              <a:t>Further characterization of the impact of antibiotic use on the microbiota and transplant outcomes important </a:t>
            </a:r>
            <a:endParaRPr lang="en-AU" sz="28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80512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350" row="0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C69D5EEA-EC56-2540-BFFD-4F4BA06B8010}">
  <we:reference id="wa200006038" version="1.0.0.3" store="en-US" storeType="OMEX"/>
  <we:alternateReferences>
    <we:reference id="WA200006038" version="1.0.0.3" store="" storeType="OMEX"/>
  </we:alternateReferences>
  <we:properties>
    <we:property name="pptx_export_from_biorender" value="false"/>
  </we:properties>
  <we:bindings/>
  <we:snapshot xmlns:r="http://schemas.openxmlformats.org/officeDocument/2006/relationships"/>
  <we:extLst>
    <a:ext xmlns:a="http://schemas.openxmlformats.org/drawingml/2006/main" uri="{0858819E-0033-43BF-8937-05EC82904868}">
      <we:backgroundApp state="1" runtimeId="Taskpane.Url"/>
    </a:ext>
  </we:extLst>
</we:webextension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B32E07EFAD3E54C82B0ADD6F67780BC" ma:contentTypeVersion="12" ma:contentTypeDescription="Create a new document." ma:contentTypeScope="" ma:versionID="ae816242d01d668c2db721fa9edcdf46">
  <xsd:schema xmlns:xsd="http://www.w3.org/2001/XMLSchema" xmlns:xs="http://www.w3.org/2001/XMLSchema" xmlns:p="http://schemas.microsoft.com/office/2006/metadata/properties" xmlns:ns3="4748f3cc-a7b3-4f74-9c2f-91806ac88731" xmlns:ns4="a50305bf-f20c-45b5-95fe-0c3b9f2af3a3" targetNamespace="http://schemas.microsoft.com/office/2006/metadata/properties" ma:root="true" ma:fieldsID="8ca5950ea94b62bb1bf2a602428f57fa" ns3:_="" ns4:_="">
    <xsd:import namespace="4748f3cc-a7b3-4f74-9c2f-91806ac88731"/>
    <xsd:import namespace="a50305bf-f20c-45b5-95fe-0c3b9f2af3a3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748f3cc-a7b3-4f74-9c2f-91806ac8873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8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9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50305bf-f20c-45b5-95fe-0c3b9f2af3a3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952490DB-A17C-4E96-B3C6-7A6120172BC3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7E85C07C-ED92-468F-ADCD-68FCA18E72E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748f3cc-a7b3-4f74-9c2f-91806ac88731"/>
    <ds:schemaRef ds:uri="a50305bf-f20c-45b5-95fe-0c3b9f2af3a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A7FC2848-6B7E-4378-81B4-50ED554E686C}">
  <ds:schemaRefs>
    <ds:schemaRef ds:uri="http://www.w3.org/XML/1998/namespace"/>
    <ds:schemaRef ds:uri="http://schemas.microsoft.com/office/2006/metadata/properties"/>
    <ds:schemaRef ds:uri="http://purl.org/dc/terms/"/>
    <ds:schemaRef ds:uri="http://purl.org/dc/dcmitype/"/>
    <ds:schemaRef ds:uri="http://schemas.microsoft.com/office/infopath/2007/PartnerControls"/>
    <ds:schemaRef ds:uri="http://purl.org/dc/elements/1.1/"/>
    <ds:schemaRef ds:uri="http://schemas.microsoft.com/office/2006/documentManagement/types"/>
    <ds:schemaRef ds:uri="http://schemas.openxmlformats.org/package/2006/metadata/core-properties"/>
    <ds:schemaRef ds:uri="a50305bf-f20c-45b5-95fe-0c3b9f2af3a3"/>
    <ds:schemaRef ds:uri="4748f3cc-a7b3-4f74-9c2f-91806ac88731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77</TotalTime>
  <Words>170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G Ison</dc:creator>
  <cp:lastModifiedBy>Olivia Smibert</cp:lastModifiedBy>
  <cp:revision>13</cp:revision>
  <dcterms:created xsi:type="dcterms:W3CDTF">2021-10-22T20:34:26Z</dcterms:created>
  <dcterms:modified xsi:type="dcterms:W3CDTF">2025-03-07T03:56:2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B32E07EFAD3E54C82B0ADD6F67780BC</vt:lpwstr>
  </property>
</Properties>
</file>